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801" r:id="rId2"/>
  </p:sldIdLst>
  <p:sldSz cx="12192000" cy="6858000"/>
  <p:notesSz cx="7011988" cy="92979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03BD"/>
    <a:srgbClr val="E226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2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473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33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079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742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16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313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820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052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802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957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937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383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B0909A8D-4D08-4C87-BD93-42DECA007484}"/>
              </a:ext>
            </a:extLst>
          </p:cNvPr>
          <p:cNvSpPr txBox="1"/>
          <p:nvPr/>
        </p:nvSpPr>
        <p:spPr>
          <a:xfrm>
            <a:off x="310630" y="330714"/>
            <a:ext cx="1157074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. 2 Ingenuity pathway analysis (IPA) predictions for European American/ Caucasian American (EA/CA)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R</a:t>
            </a:r>
            <a:r>
              <a:rPr lang="en-US" sz="1100" b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High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/mCSPC (LNCaP, VCAP, 22RV1),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R</a:t>
            </a:r>
            <a:r>
              <a:rPr lang="en-US" sz="1100" b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Low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/mCRPC/NEPC (PC-3, PC-3M, DU145) and African American (AA)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R</a:t>
            </a:r>
            <a:r>
              <a:rPr lang="en-US" sz="1100" b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High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/mCSPC (MDA-Pca-2b) PCa cell lines as well as normal prostate cell lines RWPE1 and RWPE2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1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R="0" lvl="0" algn="just">
              <a:spcBef>
                <a:spcPts val="0"/>
              </a:spcBef>
              <a:spcAft>
                <a:spcPts val="0"/>
              </a:spcAft>
              <a:tabLst>
                <a:tab pos="457200" algn="l"/>
              </a:tabLst>
            </a:pP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PA predicted A)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Diseases and biological pathways for development of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R</a:t>
            </a:r>
            <a:r>
              <a:rPr lang="en-US" sz="1100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Low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/mCRPC/NEPC. Major pathways are cell movement, morbidity, mortality, migration, invasion, survival, viability and development of vasculature- </a:t>
            </a:r>
            <a:r>
              <a:rPr lang="en-US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asculogenesis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 and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giogenesis.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ausal network pathway for development of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AR</a:t>
            </a:r>
            <a:r>
              <a:rPr lang="en-US" sz="1100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Low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/mCRPC/NEPC, which include oxidative phosphorylation, p70S6K, unfolded response, TREM1 signaling, NF-kB signaling, ERK5 signaling, IL-8 signaling, BAG2 signaling, Integrin signaling and VEGF signaling.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C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PA predicted HIF1α and EMT as key pathways associated with PCa development in African Americans (AA)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33693BA2-F814-BA63-86E2-E32C22DE8F40}"/>
              </a:ext>
            </a:extLst>
          </p:cNvPr>
          <p:cNvGrpSpPr/>
          <p:nvPr/>
        </p:nvGrpSpPr>
        <p:grpSpPr>
          <a:xfrm>
            <a:off x="203840" y="2117699"/>
            <a:ext cx="11801475" cy="3878724"/>
            <a:chOff x="203840" y="2117699"/>
            <a:chExt cx="11801475" cy="3878724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EE6D1FF1-FF8C-498C-8EC4-1F746BBDDCDD}"/>
                </a:ext>
              </a:extLst>
            </p:cNvPr>
            <p:cNvGrpSpPr/>
            <p:nvPr/>
          </p:nvGrpSpPr>
          <p:grpSpPr>
            <a:xfrm>
              <a:off x="203840" y="2117699"/>
              <a:ext cx="11801475" cy="3878724"/>
              <a:chOff x="195262" y="1169116"/>
              <a:chExt cx="11801475" cy="3878724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BCF8DE46-61BE-4211-92EE-44D70E99B3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95262" y="1169116"/>
                <a:ext cx="11801475" cy="3878724"/>
              </a:xfrm>
              <a:prstGeom prst="rect">
                <a:avLst/>
              </a:prstGeom>
            </p:spPr>
          </p:pic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43DF8ED2-5DE6-403C-9A44-0DE13ABCC14F}"/>
                  </a:ext>
                </a:extLst>
              </p:cNvPr>
              <p:cNvGrpSpPr/>
              <p:nvPr/>
            </p:nvGrpSpPr>
            <p:grpSpPr>
              <a:xfrm>
                <a:off x="5281300" y="1232802"/>
                <a:ext cx="5898054" cy="1460782"/>
                <a:chOff x="5281300" y="1232802"/>
                <a:chExt cx="5898054" cy="1460782"/>
              </a:xfrm>
            </p:grpSpPr>
            <p:sp>
              <p:nvSpPr>
                <p:cNvPr id="4" name="Rectangle 3">
                  <a:extLst>
                    <a:ext uri="{FF2B5EF4-FFF2-40B4-BE49-F238E27FC236}">
                      <a16:creationId xmlns:a16="http://schemas.microsoft.com/office/drawing/2014/main" id="{0978A92E-F0AA-4C70-AAC2-150FA8EC0182}"/>
                    </a:ext>
                  </a:extLst>
                </p:cNvPr>
                <p:cNvSpPr/>
                <p:nvPr/>
              </p:nvSpPr>
              <p:spPr>
                <a:xfrm>
                  <a:off x="5982056" y="1264778"/>
                  <a:ext cx="4836920" cy="256373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8648D2AC-DF71-4353-B3F0-933AB76F6AE4}"/>
                    </a:ext>
                  </a:extLst>
                </p:cNvPr>
                <p:cNvSpPr txBox="1"/>
                <p:nvPr/>
              </p:nvSpPr>
              <p:spPr>
                <a:xfrm>
                  <a:off x="5879505" y="1232802"/>
                  <a:ext cx="529984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AA-AR</a:t>
                  </a:r>
                  <a:r>
                    <a:rPr kumimoji="0" lang="en-US" sz="1200" b="1" i="0" u="none" strike="noStrike" kern="120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High</a:t>
                  </a: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/mCSPC Vs. Normal Prostate Common Canonical Pathways </a:t>
                  </a:r>
                </a:p>
              </p:txBody>
            </p:sp>
            <p:sp>
              <p:nvSpPr>
                <p:cNvPr id="5" name="Rectangle 4">
                  <a:extLst>
                    <a:ext uri="{FF2B5EF4-FFF2-40B4-BE49-F238E27FC236}">
                      <a16:creationId xmlns:a16="http://schemas.microsoft.com/office/drawing/2014/main" id="{381240CA-100F-4EA0-B4BF-BFE2D619034E}"/>
                    </a:ext>
                  </a:extLst>
                </p:cNvPr>
                <p:cNvSpPr/>
                <p:nvPr/>
              </p:nvSpPr>
              <p:spPr>
                <a:xfrm>
                  <a:off x="5289846" y="2315911"/>
                  <a:ext cx="2589376" cy="16237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38AB4301-6634-4075-AF7F-7B591B76E138}"/>
                    </a:ext>
                  </a:extLst>
                </p:cNvPr>
                <p:cNvSpPr/>
                <p:nvPr/>
              </p:nvSpPr>
              <p:spPr>
                <a:xfrm>
                  <a:off x="5281300" y="2505576"/>
                  <a:ext cx="2452644" cy="16237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B5BE82E5-0C22-4E1A-A118-294CF68C6951}"/>
                    </a:ext>
                  </a:extLst>
                </p:cNvPr>
                <p:cNvSpPr txBox="1"/>
                <p:nvPr/>
              </p:nvSpPr>
              <p:spPr>
                <a:xfrm>
                  <a:off x="6155818" y="2262697"/>
                  <a:ext cx="2714713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1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Role of Osteoblasts and Chondrocytes in Rheumatoid Arthritis</a:t>
                  </a:r>
                </a:p>
              </p:txBody>
            </p:sp>
          </p:grpSp>
        </p:grp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853379FA-FCE3-DC67-3854-E15AB3FC6044}"/>
                </a:ext>
              </a:extLst>
            </p:cNvPr>
            <p:cNvSpPr/>
            <p:nvPr/>
          </p:nvSpPr>
          <p:spPr>
            <a:xfrm>
              <a:off x="299104" y="2204814"/>
              <a:ext cx="102548" cy="1110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18CB1EF-D371-A998-F3E9-3C0DF178ABB6}"/>
                </a:ext>
              </a:extLst>
            </p:cNvPr>
            <p:cNvSpPr/>
            <p:nvPr/>
          </p:nvSpPr>
          <p:spPr>
            <a:xfrm>
              <a:off x="2934865" y="2204815"/>
              <a:ext cx="107437" cy="1025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633F1C03-CDE4-8788-6179-3AC8779CA12F}"/>
                </a:ext>
              </a:extLst>
            </p:cNvPr>
            <p:cNvSpPr/>
            <p:nvPr/>
          </p:nvSpPr>
          <p:spPr>
            <a:xfrm>
              <a:off x="5298423" y="2230452"/>
              <a:ext cx="229281" cy="1623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9EAF6706-7D48-6E20-D356-D51F3262BF76}"/>
              </a:ext>
            </a:extLst>
          </p:cNvPr>
          <p:cNvSpPr txBox="1"/>
          <p:nvPr/>
        </p:nvSpPr>
        <p:spPr>
          <a:xfrm>
            <a:off x="3179037" y="1936867"/>
            <a:ext cx="1884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en-US" sz="11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7CC62CA-817A-A0DC-02B8-BC728FBD3BE4}"/>
              </a:ext>
            </a:extLst>
          </p:cNvPr>
          <p:cNvSpPr txBox="1"/>
          <p:nvPr/>
        </p:nvSpPr>
        <p:spPr>
          <a:xfrm>
            <a:off x="624034" y="1942794"/>
            <a:ext cx="1884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2A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AB4CCF9-3EE8-F1E9-E097-21CA8CB31266}"/>
              </a:ext>
            </a:extLst>
          </p:cNvPr>
          <p:cNvSpPr txBox="1"/>
          <p:nvPr/>
        </p:nvSpPr>
        <p:spPr>
          <a:xfrm>
            <a:off x="7500765" y="1950782"/>
            <a:ext cx="188464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2C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81493073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6</TotalTime>
  <Words>208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swi Mitra Ghosh</dc:creator>
  <cp:lastModifiedBy>AMIT MITRA</cp:lastModifiedBy>
  <cp:revision>114</cp:revision>
  <cp:lastPrinted>2022-04-06T04:19:54Z</cp:lastPrinted>
  <dcterms:created xsi:type="dcterms:W3CDTF">2021-11-23T16:14:52Z</dcterms:created>
  <dcterms:modified xsi:type="dcterms:W3CDTF">2023-05-31T16:09:15Z</dcterms:modified>
</cp:coreProperties>
</file>